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1454" y="-3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4962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3230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574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3506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5957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3268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3888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1562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581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800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6371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35542-3C80-4E71-89ED-18E0F38DD5D0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47844-6A0E-444E-96B3-0543E663B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326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C04A601-37EA-1720-02C7-9D74E6FEF6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7326" y="-1"/>
            <a:ext cx="7789154" cy="626146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E4110278-89E2-AA8C-4F21-24E44909ED19}"/>
              </a:ext>
            </a:extLst>
          </p:cNvPr>
          <p:cNvSpPr txBox="1"/>
          <p:nvPr/>
        </p:nvSpPr>
        <p:spPr>
          <a:xfrm>
            <a:off x="-8963727" y="11479473"/>
            <a:ext cx="19270871" cy="25872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234161" algn="just">
              <a:lnSpc>
                <a:spcPct val="95000"/>
              </a:lnSpc>
              <a:spcBef>
                <a:spcPts val="1897"/>
              </a:spcBef>
              <a:spcAft>
                <a:spcPts val="3792"/>
              </a:spcAft>
            </a:pP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| </a:t>
            </a:r>
            <a:r>
              <a:rPr lang="en-US" altLang="zh-CN" sz="2844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estrone and AKT1-17 beta estradiol complex. 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2844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estrone complex in 50–100 ns. 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2844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our free energies and total binding free energy of the AKT1-estrone complex in 50–100 ns.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altLang="zh-CN" sz="2844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17 beta estradiol complex in 50–100 ns. </a:t>
            </a:r>
            <a:r>
              <a:rPr lang="en-US" altLang="zh-CN" sz="2844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2844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our free energies and total binding free energy of the AKT1-17 beta estradiol complex in 50–100 ns.</a:t>
            </a:r>
            <a:endParaRPr lang="zh-CN" altLang="zh-CN" sz="2844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EEFE9E9-833D-5A14-5989-CCB5E86F80A9}"/>
              </a:ext>
            </a:extLst>
          </p:cNvPr>
          <p:cNvSpPr txBox="1"/>
          <p:nvPr/>
        </p:nvSpPr>
        <p:spPr>
          <a:xfrm>
            <a:off x="-638378" y="6239369"/>
            <a:ext cx="12830378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2. |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estrone and AKT1-17 beta estradiol complex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estrone complex in 50–100 ns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our free energies and total binding free energy of the AKT1-estrone complex in 50–100 ns.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binding free energy of the AKT1-17 beta estradiol complex in 50–100 ns.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four free energies and total binding free energy of the AKT1-17 beta estradiol complex in 50–100 ns.</a:t>
            </a:r>
            <a:endParaRPr lang="zh-CN" altLang="zh-CN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3291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4</TotalTime>
  <Words>183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凌宇</dc:creator>
  <cp:lastModifiedBy>MDPI</cp:lastModifiedBy>
  <cp:revision>4</cp:revision>
  <dcterms:created xsi:type="dcterms:W3CDTF">2023-05-27T11:49:37Z</dcterms:created>
  <dcterms:modified xsi:type="dcterms:W3CDTF">2023-06-17T14:15:20Z</dcterms:modified>
</cp:coreProperties>
</file>